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5" r:id="rId2"/>
    <p:sldId id="274" r:id="rId3"/>
    <p:sldId id="276" r:id="rId4"/>
  </p:sldIdLst>
  <p:sldSz cx="6858000" cy="9906000" type="A4"/>
  <p:notesSz cx="6858000" cy="9144000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D7D31"/>
    <a:srgbClr val="C676E8"/>
    <a:srgbClr val="82C8EE"/>
    <a:srgbClr val="E49C00"/>
    <a:srgbClr val="FF7D45"/>
    <a:srgbClr val="FFDB13"/>
    <a:srgbClr val="65CBF3"/>
    <a:srgbClr val="0053D6"/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384" autoAdjust="0"/>
    <p:restoredTop sz="94660"/>
  </p:normalViewPr>
  <p:slideViewPr>
    <p:cSldViewPr>
      <p:cViewPr varScale="1">
        <p:scale>
          <a:sx n="72" d="100"/>
          <a:sy n="72" d="100"/>
        </p:scale>
        <p:origin x="2892" y="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BE5140-8302-9B2D-3F21-32AB059A63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5C7244-C587-F3D1-00BE-2353DF2E4A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4FA249-7387-19DB-C3A0-DE757C79A7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A4F84D-348B-4B61-939F-73EF5B346D39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1857680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ED42EC-2D3A-8B2B-FA47-AA28390CA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CC80EE-0930-885D-23D1-373BCDBE53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E04213-7CDD-BAD3-94C1-5C8DCD4761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8D327C-F657-471F-B2F2-F1D533F124F8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4576061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0B0C41-DAD9-44A3-A50B-FCB703F68B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D680E9-3304-54A3-E649-77202D2225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C8F45F-4B62-5419-CBE3-1FA4F5E4B2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69AA963-17DA-4557-BA0B-C424E47E6E43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39518277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B4773D-938F-6B8A-C911-038076B2B6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96D6E1-9674-35CD-1935-AC7F42A21D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465A69-EBA2-1230-FE36-7C5C30DAED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376635-D2BE-447D-A8E0-0E91B88B1F35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21800367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2F49F7-7D8E-59F9-BADC-6C4D8C3E2F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FD4DBD-9978-36CA-EEA8-1E942EC29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B3E565-0984-D4DD-156E-6B431DEECC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48A97C-3FC6-4AE9-9EAA-3A34221B5644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16449390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6DB9BB44-1D51-55B2-7A06-CE17F230B3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F74BB4B9-8A52-263D-0F7F-F474E0F4B3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857AF932-CCA8-5068-531D-91178D92F1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DB57CC7-7D65-41B9-87BF-AC838133DDF6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38432761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BB0C9E6D-A88D-AFA2-31D9-2BE6A598DC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CC006ADD-6937-7FCB-41F3-55FE8E386C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C889F964-E9F5-C997-2FB4-C4B68B8F3A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7CE635-C0AB-4AA1-ADC0-22B4A59BEA39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28144168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8DE14A8F-B4D7-CE02-3228-A8A26A8F6B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07A074D4-9DB7-9025-0D01-755913E81C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26A6DE34-4B64-3D97-1B38-8EECBE575D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7A664A-00A5-424B-9053-8FB50AEDA109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3303956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FC15ABF7-B669-20CA-D95F-0045CCF16B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AFADA905-0092-0068-C8D8-F7C242A752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E1FD377F-EB10-3A6D-C158-587BC62C9A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350D01-D849-41D7-9730-8775079DF7B9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39910295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6B0369C5-1484-5B53-DECC-6F54762BC8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4186AE85-2039-1D7A-7E16-6B7D4BB574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00E18193-3403-40D2-06E1-0ADBA7E914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A7D8AB-CF7A-4E8A-83BB-AF2EF7BC4E07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2025774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zh-CN" altLang="en-US" noProof="0"/>
              <a:t>单击图标添加图片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6F339130-5328-6E63-6DE6-2D96980BA1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5145CCBD-2F76-F430-9E56-CE3718492C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00755C82-F0A7-F81F-C865-89D6C57309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A92A8F-30BC-4DE8-95EC-DD2122A4BEC2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19352486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1D525F39-C952-D0DA-F15F-18A792D5A4B8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471488" y="527050"/>
            <a:ext cx="5915025" cy="1914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8444B4-B0E4-2FFD-AF2E-532E0C4624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6838"/>
            <a:ext cx="5915025" cy="62849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38D736-C984-4221-20B1-8057DCA7C1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58D855-D58C-7663-AFCD-A1692201984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2916C0-21EC-8FC7-97F7-803B47E8962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9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81B530BA-728B-4986-9E54-71B2C9AD5D72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2pPr>
      <a:lvl3pPr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3pPr>
      <a:lvl4pPr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4pPr>
      <a:lvl5pPr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171450" indent="-171450" algn="l" defTabSz="685800" rtl="0" fontAlgn="base">
        <a:lnSpc>
          <a:spcPct val="90000"/>
        </a:lnSpc>
        <a:spcBef>
          <a:spcPts val="750"/>
        </a:spcBef>
        <a:spcAft>
          <a:spcPct val="0"/>
        </a:spcAft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fontAlgn="base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fontAlgn="base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fontAlgn="base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fontAlgn="base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784D547E-A03C-7A45-5B2E-AE9BA69F8BFB}"/>
              </a:ext>
            </a:extLst>
          </p:cNvPr>
          <p:cNvSpPr txBox="1"/>
          <p:nvPr/>
        </p:nvSpPr>
        <p:spPr>
          <a:xfrm>
            <a:off x="396000" y="1008000"/>
            <a:ext cx="1273104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AtNOD19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b (LOC102666323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1 (LOC106794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c (LOC106794488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2 (LOC10082027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2 (LOC10266492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1 (LOC100792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e1 (LOC100791925)</a:t>
            </a:r>
          </a:p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mNOD19e1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0" lang="zh-CN" altLang="zh-CN" sz="6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OC100815629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f (LOC100803184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1 (LOC100785991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2 (LOC100784767)</a:t>
            </a: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727EFC5D-411D-E534-8CB1-1B9D21E5B8E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50"/>
          <a:stretch/>
        </p:blipFill>
        <p:spPr>
          <a:xfrm>
            <a:off x="1628800" y="100667"/>
            <a:ext cx="5229200" cy="9704665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8BF81AA5-1E6A-3FC9-A7D5-BA489DDB42B1}"/>
              </a:ext>
            </a:extLst>
          </p:cNvPr>
          <p:cNvSpPr txBox="1"/>
          <p:nvPr/>
        </p:nvSpPr>
        <p:spPr>
          <a:xfrm>
            <a:off x="396000" y="2556000"/>
            <a:ext cx="1273104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AtNOD19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b (LOC102666323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1 (LOC106794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c (LOC106794488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2 (LOC10082027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2 (LOC10266492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1 (LOC100792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e1 (LOC100791925)</a:t>
            </a:r>
          </a:p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mNOD19e1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0" lang="zh-CN" altLang="zh-CN" sz="6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OC100815629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f (LOC100803184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1 (LOC100785991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2 (LOC100784767)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9F2E6A4A-E4C2-0DF1-F34A-11B136CF2913}"/>
              </a:ext>
            </a:extLst>
          </p:cNvPr>
          <p:cNvSpPr txBox="1"/>
          <p:nvPr/>
        </p:nvSpPr>
        <p:spPr>
          <a:xfrm>
            <a:off x="396000" y="4086000"/>
            <a:ext cx="1273104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AtNOD19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b (LOC102666323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1 (LOC106794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c (LOC106794488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2 (LOC10082027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2 (LOC10266492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1 (LOC100792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e1 (LOC100791925)</a:t>
            </a:r>
          </a:p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mNOD19e1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0" lang="zh-CN" altLang="zh-CN" sz="6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OC100815629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f (LOC100803184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1 (LOC100785991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2 (LOC100784767)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62634B17-18FB-F045-BCF4-B431229EDA7B}"/>
              </a:ext>
            </a:extLst>
          </p:cNvPr>
          <p:cNvSpPr txBox="1"/>
          <p:nvPr/>
        </p:nvSpPr>
        <p:spPr>
          <a:xfrm>
            <a:off x="396000" y="5634000"/>
            <a:ext cx="1273104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AtNOD19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b (LOC102666323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1 (LOC106794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c (LOC106794488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2 (LOC10082027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2 (LOC10266492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1 (LOC100792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e1 (LOC100791925)</a:t>
            </a:r>
          </a:p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mNOD19e1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0" lang="zh-CN" altLang="zh-CN" sz="6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OC100815629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f (LOC100803184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1 (LOC100785991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2 (LOC100784767)</a:t>
            </a: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68AB66F-8E00-C6D3-D26F-A13EDC85B502}"/>
              </a:ext>
            </a:extLst>
          </p:cNvPr>
          <p:cNvSpPr txBox="1"/>
          <p:nvPr/>
        </p:nvSpPr>
        <p:spPr>
          <a:xfrm>
            <a:off x="396000" y="7146000"/>
            <a:ext cx="1273104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AtNOD19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b (LOC102666323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1 (LOC106794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c (LOC106794488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2 (LOC10082027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2 (LOC10266492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1 (LOC100792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e1 (LOC100791925)</a:t>
            </a:r>
          </a:p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mNOD19e1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0" lang="zh-CN" altLang="zh-CN" sz="6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OC100815629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f (LOC100803184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1 (LOC100785991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2 (LOC100784767)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5EAE26DF-873C-FCFE-A953-6DAF9792749C}"/>
              </a:ext>
            </a:extLst>
          </p:cNvPr>
          <p:cNvSpPr txBox="1"/>
          <p:nvPr/>
        </p:nvSpPr>
        <p:spPr>
          <a:xfrm>
            <a:off x="0" y="187834"/>
            <a:ext cx="68580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le 1 Multiple sequence alignment of Arabidopsis NOD19 and eleven soybean homologs.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equences were aligned by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Clustal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Omega (https://www.ebi.ac.uk/Tools/msa/clustalo/) and visualized by ESPript3 (https://espript.ibcp.fr/ESPript/ESPript/index.php)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25397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A42C6F7A-FB6C-2FDC-59C6-8E67D3CE551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50"/>
          <a:stretch/>
        </p:blipFill>
        <p:spPr>
          <a:xfrm>
            <a:off x="1628800" y="100667"/>
            <a:ext cx="5229200" cy="9704665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D1DF2906-E16B-BD67-06C2-A728DC65284A}"/>
              </a:ext>
            </a:extLst>
          </p:cNvPr>
          <p:cNvSpPr txBox="1"/>
          <p:nvPr/>
        </p:nvSpPr>
        <p:spPr>
          <a:xfrm>
            <a:off x="396000" y="1008000"/>
            <a:ext cx="1273104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AtNOD19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b (LOC102666323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1 (LOC106794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c (LOC106794488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2 (LOC10082027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2 (LOC10266492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1 (LOC100792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e1 (LOC100791925)</a:t>
            </a:r>
          </a:p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mNOD19e1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0" lang="zh-CN" altLang="zh-CN" sz="6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OC100815629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f (LOC100803184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1 (LOC100785991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2 (LOC100784767)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BFF6408D-CF1E-32A1-3A15-84DD951B2DFD}"/>
              </a:ext>
            </a:extLst>
          </p:cNvPr>
          <p:cNvSpPr txBox="1"/>
          <p:nvPr/>
        </p:nvSpPr>
        <p:spPr>
          <a:xfrm>
            <a:off x="396000" y="2556000"/>
            <a:ext cx="1273104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AtNOD19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b (LOC102666323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1 (LOC106794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c (LOC106794488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2 (LOC10082027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2 (LOC10266492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1 (LOC100792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e1 (LOC100791925)</a:t>
            </a:r>
          </a:p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mNOD19e1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0" lang="zh-CN" altLang="zh-CN" sz="6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OC100815629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f (LOC100803184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1 (LOC100785991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2 (LOC100784767)</a:t>
            </a: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F0E32893-A4E0-4319-36B0-D8B60405F8A2}"/>
              </a:ext>
            </a:extLst>
          </p:cNvPr>
          <p:cNvSpPr txBox="1"/>
          <p:nvPr/>
        </p:nvSpPr>
        <p:spPr>
          <a:xfrm>
            <a:off x="396000" y="4086000"/>
            <a:ext cx="1273104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AtNOD19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b (LOC102666323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1 (LOC106794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c (LOC106794488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2 (LOC10082027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2 (LOC10266492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1 (LOC100792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e1 (LOC100791925)</a:t>
            </a:r>
          </a:p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mNOD19e1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0" lang="zh-CN" altLang="zh-CN" sz="6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OC100815629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f (LOC100803184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1 (LOC100785991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2 (LOC100784767)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EC606954-C044-8D1F-49EB-B5A279E56502}"/>
              </a:ext>
            </a:extLst>
          </p:cNvPr>
          <p:cNvSpPr txBox="1"/>
          <p:nvPr/>
        </p:nvSpPr>
        <p:spPr>
          <a:xfrm>
            <a:off x="396000" y="5634000"/>
            <a:ext cx="1273104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AtNOD19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b (LOC102666323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1 (LOC106794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c (LOC106794488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2 (LOC10082027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2 (LOC10266492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1 (LOC100792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e1 (LOC100791925)</a:t>
            </a:r>
          </a:p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mNOD19e1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0" lang="zh-CN" altLang="zh-CN" sz="6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OC100815629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f (LOC100803184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1 (LOC100785991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2 (LOC100784767)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D7743A7-E517-EE4E-885E-3C2C501D31DA}"/>
              </a:ext>
            </a:extLst>
          </p:cNvPr>
          <p:cNvSpPr txBox="1"/>
          <p:nvPr/>
        </p:nvSpPr>
        <p:spPr>
          <a:xfrm>
            <a:off x="396000" y="7146000"/>
            <a:ext cx="1273104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AtNOD19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b (LOC102666323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1 (LOC106794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c (LOC106794488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2 (LOC10082027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2 (LOC10266492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1 (LOC100792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e1 (LOC100791925)</a:t>
            </a:r>
          </a:p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mNOD19e1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0" lang="zh-CN" altLang="zh-CN" sz="6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OC100815629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f (LOC100803184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1 (LOC100785991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2 (LOC100784767)</a:t>
            </a:r>
          </a:p>
        </p:txBody>
      </p:sp>
    </p:spTree>
    <p:extLst>
      <p:ext uri="{BB962C8B-B14F-4D97-AF65-F5344CB8AC3E}">
        <p14:creationId xmlns:p14="http://schemas.microsoft.com/office/powerpoint/2010/main" val="30352546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167657D5-2FAB-799D-93AE-C3C3352A3B7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50"/>
          <a:stretch/>
        </p:blipFill>
        <p:spPr>
          <a:xfrm>
            <a:off x="1628800" y="100667"/>
            <a:ext cx="5229200" cy="9704665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DC5A8840-A80C-DA0A-7310-5763C2843BFA}"/>
              </a:ext>
            </a:extLst>
          </p:cNvPr>
          <p:cNvSpPr txBox="1"/>
          <p:nvPr/>
        </p:nvSpPr>
        <p:spPr>
          <a:xfrm>
            <a:off x="396000" y="1008000"/>
            <a:ext cx="1273104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AtNOD19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b (LOC102666323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1 (LOC106794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c (LOC106794488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2 (LOC10082027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2 (LOC10266492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1 (LOC100792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e1 (LOC100791925)</a:t>
            </a:r>
          </a:p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mNOD19e1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0" lang="zh-CN" altLang="zh-CN" sz="6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OC100815629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f (LOC100803184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1 (LOC100785991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2 (LOC100784767)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2691B13F-A9D9-E865-8BB2-9579454384C0}"/>
              </a:ext>
            </a:extLst>
          </p:cNvPr>
          <p:cNvSpPr txBox="1"/>
          <p:nvPr/>
        </p:nvSpPr>
        <p:spPr>
          <a:xfrm>
            <a:off x="396000" y="2556000"/>
            <a:ext cx="1273104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AtNOD19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b (LOC102666323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1 (LOC106794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c (LOC106794488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2 (LOC10082027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2 (LOC10266492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1 (LOC100792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e1 (LOC100791925)</a:t>
            </a:r>
          </a:p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mNOD19e1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0" lang="zh-CN" altLang="zh-CN" sz="6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OC100815629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f (LOC100803184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1 (LOC100785991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2 (LOC100784767)</a:t>
            </a: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5633DD60-0398-C040-5C69-A389C0C7A319}"/>
              </a:ext>
            </a:extLst>
          </p:cNvPr>
          <p:cNvSpPr txBox="1"/>
          <p:nvPr/>
        </p:nvSpPr>
        <p:spPr>
          <a:xfrm>
            <a:off x="396000" y="4086000"/>
            <a:ext cx="1273104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AtNOD19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b (LOC102666323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1 (LOC106794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c (LOC106794488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2 (LOC10082027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2 (LOC10266492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1 (LOC100792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e1 (LOC100791925)</a:t>
            </a:r>
          </a:p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mNOD19e1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0" lang="zh-CN" altLang="zh-CN" sz="6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OC100815629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f (LOC100803184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1 (LOC100785991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2 (LOC100784767)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EB379D3F-E928-6FF0-F1DD-532C4FC89162}"/>
              </a:ext>
            </a:extLst>
          </p:cNvPr>
          <p:cNvSpPr txBox="1"/>
          <p:nvPr/>
        </p:nvSpPr>
        <p:spPr>
          <a:xfrm>
            <a:off x="396000" y="5634000"/>
            <a:ext cx="1273104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AtNOD19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b (LOC102666323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1 (LOC106794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c (LOC106794488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d2 (LOC10082027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2 (LOC102664925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a1 (LOC100792489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e1 (LOC100791925)</a:t>
            </a:r>
          </a:p>
          <a:p>
            <a:pPr algn="r">
              <a:lnSpc>
                <a:spcPts val="610"/>
              </a:lnSpc>
            </a:pP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mNOD19e1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0" lang="zh-CN" altLang="zh-CN" sz="6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OC100815629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f (LOC100803184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1 (LOC100785991)</a:t>
            </a:r>
          </a:p>
          <a:p>
            <a:pPr algn="r">
              <a:lnSpc>
                <a:spcPts val="610"/>
              </a:lnSpc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mNOD19g2 (LOC100784767)</a:t>
            </a:r>
          </a:p>
        </p:txBody>
      </p:sp>
    </p:spTree>
    <p:extLst>
      <p:ext uri="{BB962C8B-B14F-4D97-AF65-F5344CB8AC3E}">
        <p14:creationId xmlns:p14="http://schemas.microsoft.com/office/powerpoint/2010/main" val="29371836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1927</TotalTime>
  <Words>702</Words>
  <Application>Microsoft Office PowerPoint</Application>
  <PresentationFormat>A4 纸张(210x297 毫米)</PresentationFormat>
  <Paragraphs>169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程晓非</dc:creator>
  <cp:lastModifiedBy>xfcheng@neau.edu.cn</cp:lastModifiedBy>
  <cp:revision>65</cp:revision>
  <dcterms:created xsi:type="dcterms:W3CDTF">2023-02-15T07:53:58Z</dcterms:created>
  <dcterms:modified xsi:type="dcterms:W3CDTF">2023-05-29T07:00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8.1.0.2424</vt:lpwstr>
  </property>
</Properties>
</file>